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-330" y="5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617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4917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44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60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178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5830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0009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992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494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2693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664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776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69" name="Picture 4" descr="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9295" y="1086831"/>
            <a:ext cx="8156575" cy="4587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 Box 1"/>
          <p:cNvSpPr txBox="1">
            <a:spLocks noChangeArrowheads="1"/>
          </p:cNvSpPr>
          <p:nvPr/>
        </p:nvSpPr>
        <p:spPr bwMode="auto">
          <a:xfrm>
            <a:off x="1089545" y="769331"/>
            <a:ext cx="7185025" cy="3143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6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 Box 3"/>
          <p:cNvSpPr txBox="1">
            <a:spLocks noChangeArrowheads="1"/>
          </p:cNvSpPr>
          <p:nvPr/>
        </p:nvSpPr>
        <p:spPr bwMode="auto">
          <a:xfrm>
            <a:off x="884757" y="5898544"/>
            <a:ext cx="7385051" cy="7715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pid Signatures Associated with PSA-PFS Using Alternative Patient Groupings.</a:t>
            </a:r>
            <a:endParaRPr kumimoji="0" lang="en-US" altLang="en-U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tmaps comparing lipid fold changes between patients with longer versus shorter PSA-PFS time, addressing the challenge of defining patient groups. (A) Comparison of the three patients with the longest PSA-PFS time versus the three with the shortest. (B) Comparison of patients with PSA-PFS longer than 6 months versus less than 6 months. </a:t>
            </a:r>
            <a:endParaRPr kumimoji="0" lang="en-US" altLang="en-US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1629295" y="-68164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2713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V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ak Talmor - SVHNS</dc:creator>
  <cp:lastModifiedBy>Barak Talmor - SVHNS</cp:lastModifiedBy>
  <cp:revision>7</cp:revision>
  <dcterms:created xsi:type="dcterms:W3CDTF">2026-02-22T23:33:58Z</dcterms:created>
  <dcterms:modified xsi:type="dcterms:W3CDTF">2026-02-22T23:39:09Z</dcterms:modified>
</cp:coreProperties>
</file>